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84201"/>
  </p:normalViewPr>
  <p:slideViewPr>
    <p:cSldViewPr snapToGrid="0" snapToObjects="1">
      <p:cViewPr varScale="1">
        <p:scale>
          <a:sx n="101" d="100"/>
          <a:sy n="101" d="100"/>
        </p:scale>
        <p:origin x="232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9E37-C59B-B348-B051-EE389495585E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D6D64-4201-BD42-BC82-5D1E8ED66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26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defRPr/>
            </a:pPr>
            <a:fld id="{11139F6A-FB59-5A48-A80B-C997DA68CCA6}" type="slidenum">
              <a:rPr lang="en-US" sz="1200">
                <a:solidFill>
                  <a:srgbClr val="000000"/>
                </a:solidFill>
              </a:rPr>
              <a:pPr defTabSz="914400" eaLnBrk="1" fontAlgn="base" hangingPunct="1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sz="1200">
              <a:solidFill>
                <a:srgbClr val="000000"/>
              </a:solidFill>
            </a:endParaRPr>
          </a:p>
        </p:txBody>
      </p:sp>
      <p:sp>
        <p:nvSpPr>
          <p:cNvPr id="1536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ln/>
        </p:spPr>
      </p:sp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upplementary Fig 12a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: 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Binge eating group </a:t>
            </a:r>
            <a:r>
              <a:rPr lang="en-US" b="1" baseline="0" dirty="0">
                <a:latin typeface="Arial" charset="0"/>
                <a:ea typeface="ＭＳ Ｐゴシック" charset="0"/>
                <a:cs typeface="ＭＳ Ｐゴシック" charset="0"/>
              </a:rPr>
              <a:t>differences by stress condition for low-ED vs. high-ED food contrast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Both columns illustrate areas showing differential activation for the high-ED vs low-ED contrast between groups (BE vs. NB), with effects in the non-stress condition shown on the left column, and effects in the stress condition on the right column.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;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Cer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indicates cerebellum; OFC, orbitofrontal cortex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Caud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caudate; IP, inferior parietal cortex; Cu, cuneus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dACC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dorsal anterior cingulate cortex; Sens-Mot, sensorimotor cortex; SMA, supplementary motor area; MTG, middle temporal gyrus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Thal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thalamus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sPFC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superior prefrontal cortex</a:t>
            </a:r>
            <a:endParaRPr lang="en-US" b="1" dirty="0">
              <a:latin typeface="Arial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96044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0F2C8-7675-0642-A16C-4A1AF148D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2CED4B-BEFE-F940-9C7A-CD73253C3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34A5-25E2-B447-A53F-9D073353C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60D2-C67F-C344-8750-90720D270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D513-73C0-064B-ACFB-0CD31BBB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684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A7C21-050C-4045-B9F2-6D15D88BE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D30-3ED2-534E-B147-B47FA7B8F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F94A0-AB30-F940-8077-8D85C74E4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FD6D-8140-EC4A-8EAE-20D09AAD7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6BA17F-104B-7245-B6AB-4E35888AE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A04A82-733E-A243-8105-DE4FD7FDC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604C-882A-3A4A-9FE0-FE83ED19F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9A4B4-6917-F940-8ACF-2FCFD746D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4ACE-77C5-DC41-A118-B7B70BAC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A29F-433C-B04D-BB3E-3399305D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E4B0-6E96-C84B-A3AC-F3135A28F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4D220-4A31-7C45-B2D5-C175828D3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E3EE-4221-A64A-A74A-B771152A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F6FF6-04A3-414C-BC56-DFEEC160F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2E7C-1087-7645-BA81-F17C7C84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101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2464-FD62-9C46-A480-8D6BD3B5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BBDD6-A130-5945-BDE9-7CA58DDDC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F79F7-24F3-F84D-9E88-B2E39E614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47250-D516-8647-83D6-BBBC0E65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FE0C-07A4-F64C-BF98-8FD27540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2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14193-C656-DC46-B8A9-B222FF13E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A7DBE-8998-3A4D-B673-039F0088AD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0B051-E8C6-984C-80BC-143185EE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8911C-93BF-4243-A980-F865C20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5D9BC-102C-124D-949A-472C7255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95380-B911-D14F-AA33-5DAFB0276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2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82FA-7F5D-C24A-9B4D-182913A14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2DF9F-EC62-934C-9395-186CF6E16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69212-6AA7-6543-BB6F-E720EE1A7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701836-2BA1-2945-9ECF-DEB842F702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8A43C2-629C-0242-9FE9-645395A6F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AC270-23AB-A248-8246-DB62E97C9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7D824-A912-E34C-8A41-99E2B5A0E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5C3A9-C395-464B-A478-15D773A8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11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81D94-83EF-A04C-A85F-E0982392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CF3099-B0D0-354E-BC13-B6A23468F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995B67-1D64-334B-B516-F8F46E0E0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6DA786-63E2-A049-85CD-359BD4E8E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7D6F75-B4E9-B547-980B-FC2537D33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E4B715-FA60-4F44-BA94-D1B505102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C863A-B507-AD4E-8F5F-F9601055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B7134-60A9-8A46-B94F-C10143890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B620D0-4FB1-6044-BB3E-88172B24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BB0E6-7FD1-AC48-A895-3B3AF1688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E33AA-CF53-074D-A527-ECD01CD40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0A1CD-59D1-174F-AB97-E54F9D8A3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3175B-9859-A040-907A-F226AD84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5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806D6-7E52-044F-903F-C79DA948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380736-3B1D-4C4D-B3D3-5CD929997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4294F-49AF-084D-AB23-77441BB377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78F24-50CF-0146-ADE0-4A867254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10A44-C307-3546-9256-B78B18CD6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A5BCF7-7C11-684F-AD2C-9FB61EE3E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48FCB-C307-AC46-8F6D-BD8682C14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3C883-8B6A-9244-8646-D179FDCD7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8730C-28DB-E845-BC46-5170EA59F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75CF5-27E2-9743-8AA5-3CCFC205B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6EBC5B-EE2C-424C-A5A4-EAAD26F7E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id="{164EA5AD-3A35-A040-9F24-AFFEF5FA11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70275" y="4108931"/>
            <a:ext cx="846285" cy="1051175"/>
          </a:xfrm>
          <a:prstGeom prst="rect">
            <a:avLst/>
          </a:prstGeom>
        </p:spPr>
      </p:pic>
      <p:sp>
        <p:nvSpPr>
          <p:cNvPr id="14343" name="Text Box 14"/>
          <p:cNvSpPr txBox="1">
            <a:spLocks noChangeArrowheads="1"/>
          </p:cNvSpPr>
          <p:nvPr/>
        </p:nvSpPr>
        <p:spPr bwMode="auto">
          <a:xfrm>
            <a:off x="3733800" y="533401"/>
            <a:ext cx="4648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</a:pPr>
            <a:r>
              <a:rPr lang="en-US" sz="1400" b="1" dirty="0">
                <a:solidFill>
                  <a:srgbClr val="FFFF00"/>
                </a:solidFill>
              </a:rPr>
              <a:t>High-ED &gt; Low-ED</a:t>
            </a:r>
          </a:p>
        </p:txBody>
      </p:sp>
      <p:sp>
        <p:nvSpPr>
          <p:cNvPr id="14373" name="Line 53"/>
          <p:cNvSpPr>
            <a:spLocks noChangeShapeType="1"/>
          </p:cNvSpPr>
          <p:nvPr/>
        </p:nvSpPr>
        <p:spPr bwMode="auto">
          <a:xfrm>
            <a:off x="5697394" y="1412994"/>
            <a:ext cx="0" cy="403860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pPr defTabSz="914428"/>
            <a:endParaRPr lang="en-US">
              <a:solidFill>
                <a:srgbClr val="000000"/>
              </a:solidFill>
              <a:cs typeface="+mn-cs"/>
            </a:endParaRPr>
          </a:p>
        </p:txBody>
      </p:sp>
      <p:sp>
        <p:nvSpPr>
          <p:cNvPr id="51" name="TextBox 20">
            <a:extLst>
              <a:ext uri="{FF2B5EF4-FFF2-40B4-BE49-F238E27FC236}">
                <a16:creationId xmlns:a16="http://schemas.microsoft.com/office/drawing/2014/main" id="{9CE91F59-9AB5-584E-BE35-3A6AAABD5B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8734" y="2572567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/>
            <a:r>
              <a:rPr lang="en-US" sz="1200" dirty="0" err="1">
                <a:solidFill>
                  <a:srgbClr val="FFFFFF"/>
                </a:solidFill>
              </a:rPr>
              <a:t>Cer</a:t>
            </a:r>
            <a:endParaRPr lang="en-US" sz="1200" dirty="0">
              <a:solidFill>
                <a:srgbClr val="FFFFFF"/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5868203-F799-1049-95FD-F1DB9AF862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9672" y="2992799"/>
            <a:ext cx="843960" cy="1020602"/>
          </a:xfrm>
          <a:prstGeom prst="rect">
            <a:avLst/>
          </a:prstGeom>
        </p:spPr>
      </p:pic>
      <p:sp>
        <p:nvSpPr>
          <p:cNvPr id="55" name="TextBox 40">
            <a:extLst>
              <a:ext uri="{FF2B5EF4-FFF2-40B4-BE49-F238E27FC236}">
                <a16:creationId xmlns:a16="http://schemas.microsoft.com/office/drawing/2014/main" id="{1CAF5AF5-D6E8-7A47-8A1F-867C95916E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2014" y="3796743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-8</a:t>
            </a:r>
          </a:p>
        </p:txBody>
      </p:sp>
      <p:sp>
        <p:nvSpPr>
          <p:cNvPr id="56" name="TextBox 29">
            <a:extLst>
              <a:ext uri="{FF2B5EF4-FFF2-40B4-BE49-F238E27FC236}">
                <a16:creationId xmlns:a16="http://schemas.microsoft.com/office/drawing/2014/main" id="{1732D4BA-28DD-4045-BF5D-4FADB745DE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6396" y="3017056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OFC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01F2BAED-C028-3144-B1D6-1C4BFBD54716}"/>
              </a:ext>
            </a:extLst>
          </p:cNvPr>
          <p:cNvCxnSpPr>
            <a:cxnSpLocks/>
          </p:cNvCxnSpPr>
          <p:nvPr/>
        </p:nvCxnSpPr>
        <p:spPr>
          <a:xfrm flipH="1">
            <a:off x="3292918" y="3197836"/>
            <a:ext cx="150626" cy="120142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29">
            <a:extLst>
              <a:ext uri="{FF2B5EF4-FFF2-40B4-BE49-F238E27FC236}">
                <a16:creationId xmlns:a16="http://schemas.microsoft.com/office/drawing/2014/main" id="{0B9170DE-68F7-9143-95D5-EFF28F149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0970" y="4385349"/>
            <a:ext cx="11729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 err="1">
                <a:solidFill>
                  <a:srgbClr val="FFFFFF"/>
                </a:solidFill>
              </a:rPr>
              <a:t>Caud</a:t>
            </a:r>
            <a:endParaRPr lang="en-US" sz="1200" dirty="0">
              <a:solidFill>
                <a:srgbClr val="FFFFFF"/>
              </a:solidFill>
            </a:endParaRPr>
          </a:p>
        </p:txBody>
      </p:sp>
      <p:sp>
        <p:nvSpPr>
          <p:cNvPr id="80" name="TextBox 20">
            <a:extLst>
              <a:ext uri="{FF2B5EF4-FFF2-40B4-BE49-F238E27FC236}">
                <a16:creationId xmlns:a16="http://schemas.microsoft.com/office/drawing/2014/main" id="{A65F17CD-ED22-A64E-89FB-33C0B58ADC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4856" y="2451433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/>
            <a:r>
              <a:rPr lang="en-US" sz="1200" dirty="0" err="1">
                <a:solidFill>
                  <a:srgbClr val="FFFFFF"/>
                </a:solidFill>
              </a:rPr>
              <a:t>Cer</a:t>
            </a:r>
            <a:endParaRPr lang="en-US" sz="1200" dirty="0">
              <a:solidFill>
                <a:srgbClr val="FFFFFF"/>
              </a:solidFill>
            </a:endParaRPr>
          </a:p>
        </p:txBody>
      </p:sp>
      <p:sp>
        <p:nvSpPr>
          <p:cNvPr id="82" name="TextBox 40">
            <a:extLst>
              <a:ext uri="{FF2B5EF4-FFF2-40B4-BE49-F238E27FC236}">
                <a16:creationId xmlns:a16="http://schemas.microsoft.com/office/drawing/2014/main" id="{3D88D21F-BE04-3E4A-AAC6-DF7F5F0501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07196" y="2681302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-26</a:t>
            </a:r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BF29E1FA-0065-594F-AE80-60C800361EA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75925" y="2963530"/>
            <a:ext cx="840634" cy="1019492"/>
          </a:xfrm>
          <a:prstGeom prst="rect">
            <a:avLst/>
          </a:prstGeom>
        </p:spPr>
      </p:pic>
      <p:sp>
        <p:nvSpPr>
          <p:cNvPr id="84" name="TextBox 40">
            <a:extLst>
              <a:ext uri="{FF2B5EF4-FFF2-40B4-BE49-F238E27FC236}">
                <a16:creationId xmlns:a16="http://schemas.microsoft.com/office/drawing/2014/main" id="{37B184E8-AAAC-8D44-B8CE-D2A25A8236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11548" y="3791656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-16</a:t>
            </a:r>
          </a:p>
        </p:txBody>
      </p:sp>
      <p:sp>
        <p:nvSpPr>
          <p:cNvPr id="85" name="TextBox 29">
            <a:extLst>
              <a:ext uri="{FF2B5EF4-FFF2-40B4-BE49-F238E27FC236}">
                <a16:creationId xmlns:a16="http://schemas.microsoft.com/office/drawing/2014/main" id="{29651F05-9918-8849-8F36-5DA1DABB17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2503" y="3055814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MTG</a:t>
            </a: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35E0183B-130F-4C42-B3E7-B4CF95C78B68}"/>
              </a:ext>
            </a:extLst>
          </p:cNvPr>
          <p:cNvCxnSpPr>
            <a:cxnSpLocks/>
          </p:cNvCxnSpPr>
          <p:nvPr/>
        </p:nvCxnSpPr>
        <p:spPr>
          <a:xfrm>
            <a:off x="6216818" y="3204199"/>
            <a:ext cx="1338118" cy="27395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TextBox 40">
            <a:extLst>
              <a:ext uri="{FF2B5EF4-FFF2-40B4-BE49-F238E27FC236}">
                <a16:creationId xmlns:a16="http://schemas.microsoft.com/office/drawing/2014/main" id="{29E9DACB-D853-8D4B-A4E9-6458EDA0AE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07190" y="4919426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-2</a:t>
            </a:r>
          </a:p>
        </p:txBody>
      </p:sp>
      <p:sp>
        <p:nvSpPr>
          <p:cNvPr id="91" name="TextBox 29">
            <a:extLst>
              <a:ext uri="{FF2B5EF4-FFF2-40B4-BE49-F238E27FC236}">
                <a16:creationId xmlns:a16="http://schemas.microsoft.com/office/drawing/2014/main" id="{515A1636-DA6D-C142-9D1F-DE7F03ECA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3924" y="4723821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Cu</a:t>
            </a:r>
          </a:p>
        </p:txBody>
      </p: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D2F3117E-1775-A940-AD67-99B31630862C}"/>
              </a:ext>
            </a:extLst>
          </p:cNvPr>
          <p:cNvCxnSpPr>
            <a:cxnSpLocks/>
          </p:cNvCxnSpPr>
          <p:nvPr/>
        </p:nvCxnSpPr>
        <p:spPr>
          <a:xfrm>
            <a:off x="6169088" y="4880438"/>
            <a:ext cx="970117" cy="19038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1" name="Picture 20">
            <a:extLst>
              <a:ext uri="{FF2B5EF4-FFF2-40B4-BE49-F238E27FC236}">
                <a16:creationId xmlns:a16="http://schemas.microsoft.com/office/drawing/2014/main" id="{01EDE63A-FB18-1648-A11A-1E7EB7A54A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78739" y="1881963"/>
            <a:ext cx="835006" cy="994501"/>
          </a:xfrm>
          <a:prstGeom prst="rect">
            <a:avLst/>
          </a:prstGeom>
        </p:spPr>
      </p:pic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425DCA64-AD21-DA41-B6AB-E18BAD93889A}"/>
              </a:ext>
            </a:extLst>
          </p:cNvPr>
          <p:cNvCxnSpPr>
            <a:cxnSpLocks/>
          </p:cNvCxnSpPr>
          <p:nvPr/>
        </p:nvCxnSpPr>
        <p:spPr>
          <a:xfrm>
            <a:off x="6216285" y="2583592"/>
            <a:ext cx="1001821" cy="171188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TextBox 29">
            <a:extLst>
              <a:ext uri="{FF2B5EF4-FFF2-40B4-BE49-F238E27FC236}">
                <a16:creationId xmlns:a16="http://schemas.microsoft.com/office/drawing/2014/main" id="{F218E22B-B38A-574E-8DC9-E0859F59C9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1201" y="4249714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 err="1">
                <a:solidFill>
                  <a:srgbClr val="FFFFFF"/>
                </a:solidFill>
              </a:rPr>
              <a:t>Thal</a:t>
            </a:r>
            <a:endParaRPr lang="en-US" sz="1200" dirty="0">
              <a:solidFill>
                <a:srgbClr val="FFFFFF"/>
              </a:solidFill>
            </a:endParaRP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0DF252F7-34DC-DC43-B6B8-486012680D49}"/>
              </a:ext>
            </a:extLst>
          </p:cNvPr>
          <p:cNvCxnSpPr>
            <a:cxnSpLocks/>
          </p:cNvCxnSpPr>
          <p:nvPr/>
        </p:nvCxnSpPr>
        <p:spPr>
          <a:xfrm>
            <a:off x="6352626" y="4414894"/>
            <a:ext cx="922594" cy="162846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:a16="http://schemas.microsoft.com/office/drawing/2014/main" id="{65358EF8-53F0-1F45-9944-66EDBD86461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33795" y="1938345"/>
            <a:ext cx="895407" cy="996014"/>
          </a:xfrm>
          <a:prstGeom prst="rect">
            <a:avLst/>
          </a:prstGeom>
        </p:spPr>
      </p:pic>
      <p:sp>
        <p:nvSpPr>
          <p:cNvPr id="114" name="TextBox 40">
            <a:extLst>
              <a:ext uri="{FF2B5EF4-FFF2-40B4-BE49-F238E27FC236}">
                <a16:creationId xmlns:a16="http://schemas.microsoft.com/office/drawing/2014/main" id="{0584BB59-6467-6240-B145-6E4AB909FD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727734" y="2676945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+52</a:t>
            </a:r>
          </a:p>
        </p:txBody>
      </p:sp>
      <p:sp>
        <p:nvSpPr>
          <p:cNvPr id="115" name="TextBox 29">
            <a:extLst>
              <a:ext uri="{FF2B5EF4-FFF2-40B4-BE49-F238E27FC236}">
                <a16:creationId xmlns:a16="http://schemas.microsoft.com/office/drawing/2014/main" id="{C87532E1-7993-D04D-9B63-85E52F8A20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2173" y="2693725"/>
            <a:ext cx="911353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Sens-</a:t>
            </a:r>
          </a:p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Mot</a:t>
            </a:r>
          </a:p>
        </p:txBody>
      </p: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204F792F-83A0-064D-A574-48004C58D6D5}"/>
              </a:ext>
            </a:extLst>
          </p:cNvPr>
          <p:cNvCxnSpPr>
            <a:cxnSpLocks/>
          </p:cNvCxnSpPr>
          <p:nvPr/>
        </p:nvCxnSpPr>
        <p:spPr>
          <a:xfrm flipV="1">
            <a:off x="8698034" y="2556525"/>
            <a:ext cx="319112" cy="171704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7" name="TextBox 29">
            <a:extLst>
              <a:ext uri="{FF2B5EF4-FFF2-40B4-BE49-F238E27FC236}">
                <a16:creationId xmlns:a16="http://schemas.microsoft.com/office/drawing/2014/main" id="{FFD45B4A-A30D-414D-AF5F-F4D2148EAB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2174" y="2094078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 err="1">
                <a:solidFill>
                  <a:srgbClr val="FFFFFF"/>
                </a:solidFill>
              </a:rPr>
              <a:t>sPFC</a:t>
            </a:r>
            <a:endParaRPr lang="en-US" sz="1200" dirty="0">
              <a:solidFill>
                <a:srgbClr val="FFFFFF"/>
              </a:solidFill>
            </a:endParaRPr>
          </a:p>
        </p:txBody>
      </p: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52E530BC-B9A9-AB46-9195-C0E805659A60}"/>
              </a:ext>
            </a:extLst>
          </p:cNvPr>
          <p:cNvCxnSpPr>
            <a:cxnSpLocks/>
          </p:cNvCxnSpPr>
          <p:nvPr/>
        </p:nvCxnSpPr>
        <p:spPr>
          <a:xfrm flipV="1">
            <a:off x="8698035" y="2146332"/>
            <a:ext cx="561953" cy="7746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3F94D6DE-2AA3-CD44-A963-9CF33EC8DCD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64082" y="1881962"/>
            <a:ext cx="849550" cy="1045560"/>
          </a:xfrm>
          <a:prstGeom prst="rect">
            <a:avLst/>
          </a:prstGeom>
        </p:spPr>
      </p:pic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4E24B9F4-2DDA-7D40-9C8E-FAE860AA8E0B}"/>
              </a:ext>
            </a:extLst>
          </p:cNvPr>
          <p:cNvCxnSpPr>
            <a:cxnSpLocks/>
          </p:cNvCxnSpPr>
          <p:nvPr/>
        </p:nvCxnSpPr>
        <p:spPr>
          <a:xfrm>
            <a:off x="2031390" y="2711065"/>
            <a:ext cx="702802" cy="26792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Oval 4">
            <a:extLst>
              <a:ext uri="{FF2B5EF4-FFF2-40B4-BE49-F238E27FC236}">
                <a16:creationId xmlns:a16="http://schemas.microsoft.com/office/drawing/2014/main" id="{4C6DF809-8A1D-D744-A810-AEE0915D2C88}"/>
              </a:ext>
            </a:extLst>
          </p:cNvPr>
          <p:cNvSpPr/>
          <p:nvPr/>
        </p:nvSpPr>
        <p:spPr>
          <a:xfrm>
            <a:off x="3362206" y="2825031"/>
            <a:ext cx="88237" cy="9813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14226" fontAlgn="auto">
              <a:spcBef>
                <a:spcPts val="0"/>
              </a:spcBef>
              <a:spcAft>
                <a:spcPts val="0"/>
              </a:spcAft>
            </a:pPr>
            <a:endParaRPr lang="en-US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TextBox 40"/>
          <p:cNvSpPr txBox="1">
            <a:spLocks noChangeArrowheads="1"/>
          </p:cNvSpPr>
          <p:nvPr/>
        </p:nvSpPr>
        <p:spPr bwMode="auto">
          <a:xfrm>
            <a:off x="3308471" y="2747017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-20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5CE074B7-42C3-CA4B-A381-1A94EEA190F1}"/>
              </a:ext>
            </a:extLst>
          </p:cNvPr>
          <p:cNvCxnSpPr>
            <a:cxnSpLocks/>
          </p:cNvCxnSpPr>
          <p:nvPr/>
        </p:nvCxnSpPr>
        <p:spPr>
          <a:xfrm>
            <a:off x="1926679" y="2703990"/>
            <a:ext cx="1062179" cy="97079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3" name="Picture 22">
            <a:extLst>
              <a:ext uri="{FF2B5EF4-FFF2-40B4-BE49-F238E27FC236}">
                <a16:creationId xmlns:a16="http://schemas.microsoft.com/office/drawing/2014/main" id="{9CCACE0D-8E96-3B4A-9194-936ED115B03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64082" y="4153915"/>
            <a:ext cx="879463" cy="1028017"/>
          </a:xfrm>
          <a:prstGeom prst="rect">
            <a:avLst/>
          </a:prstGeom>
        </p:spPr>
      </p:pic>
      <p:sp>
        <p:nvSpPr>
          <p:cNvPr id="69" name="TextBox 40">
            <a:extLst>
              <a:ext uri="{FF2B5EF4-FFF2-40B4-BE49-F238E27FC236}">
                <a16:creationId xmlns:a16="http://schemas.microsoft.com/office/drawing/2014/main" id="{113440FF-2B7E-4848-A541-20A22F11C2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1550" y="4920306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+12</a:t>
            </a: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57AA02F2-D6D7-3544-8C8D-567122B6E7BD}"/>
              </a:ext>
            </a:extLst>
          </p:cNvPr>
          <p:cNvCxnSpPr>
            <a:cxnSpLocks/>
          </p:cNvCxnSpPr>
          <p:nvPr/>
        </p:nvCxnSpPr>
        <p:spPr>
          <a:xfrm>
            <a:off x="2077459" y="4523847"/>
            <a:ext cx="776939" cy="49312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Box 29">
            <a:extLst>
              <a:ext uri="{FF2B5EF4-FFF2-40B4-BE49-F238E27FC236}">
                <a16:creationId xmlns:a16="http://schemas.microsoft.com/office/drawing/2014/main" id="{60C279A8-1555-1244-A2E4-885EFD095A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8734" y="5070818"/>
            <a:ext cx="11729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IP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EB4B5AA7-FDBA-6544-B013-BDBBBB989921}"/>
              </a:ext>
            </a:extLst>
          </p:cNvPr>
          <p:cNvCxnSpPr>
            <a:cxnSpLocks/>
          </p:cNvCxnSpPr>
          <p:nvPr/>
        </p:nvCxnSpPr>
        <p:spPr>
          <a:xfrm flipV="1">
            <a:off x="1752600" y="5079530"/>
            <a:ext cx="1015704" cy="158428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9" name="Picture 8">
            <a:extLst>
              <a:ext uri="{FF2B5EF4-FFF2-40B4-BE49-F238E27FC236}">
                <a16:creationId xmlns:a16="http://schemas.microsoft.com/office/drawing/2014/main" id="{DED8A397-5433-CE40-A309-4BB2DC07207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15364" y="1888544"/>
            <a:ext cx="831055" cy="1028925"/>
          </a:xfrm>
          <a:prstGeom prst="rect">
            <a:avLst/>
          </a:prstGeom>
        </p:spPr>
      </p:pic>
      <p:sp>
        <p:nvSpPr>
          <p:cNvPr id="66" name="TextBox 40">
            <a:extLst>
              <a:ext uri="{FF2B5EF4-FFF2-40B4-BE49-F238E27FC236}">
                <a16:creationId xmlns:a16="http://schemas.microsoft.com/office/drawing/2014/main" id="{01E95308-5194-D14A-ACCB-E72D70F0BB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52868" y="2742205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+28</a:t>
            </a:r>
          </a:p>
        </p:txBody>
      </p:sp>
      <p:sp>
        <p:nvSpPr>
          <p:cNvPr id="67" name="TextBox 29">
            <a:extLst>
              <a:ext uri="{FF2B5EF4-FFF2-40B4-BE49-F238E27FC236}">
                <a16:creationId xmlns:a16="http://schemas.microsoft.com/office/drawing/2014/main" id="{5CCD124C-4602-6F44-8F4A-DC9BB2F06C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5084" y="1934429"/>
            <a:ext cx="11729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Cu</a:t>
            </a: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D06ACAB4-D52A-5F4D-95AC-855EE535ACEE}"/>
              </a:ext>
            </a:extLst>
          </p:cNvPr>
          <p:cNvCxnSpPr>
            <a:cxnSpLocks/>
          </p:cNvCxnSpPr>
          <p:nvPr/>
        </p:nvCxnSpPr>
        <p:spPr>
          <a:xfrm flipH="1">
            <a:off x="4767490" y="2146332"/>
            <a:ext cx="423175" cy="606197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7" name="Picture 16">
            <a:extLst>
              <a:ext uri="{FF2B5EF4-FFF2-40B4-BE49-F238E27FC236}">
                <a16:creationId xmlns:a16="http://schemas.microsoft.com/office/drawing/2014/main" id="{210F373E-AF09-BC43-B8CE-8F3DC1A9479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76657" y="2984502"/>
            <a:ext cx="914658" cy="1102603"/>
          </a:xfrm>
          <a:prstGeom prst="rect">
            <a:avLst/>
          </a:prstGeom>
        </p:spPr>
      </p:pic>
      <p:sp>
        <p:nvSpPr>
          <p:cNvPr id="78" name="TextBox 40">
            <a:extLst>
              <a:ext uri="{FF2B5EF4-FFF2-40B4-BE49-F238E27FC236}">
                <a16:creationId xmlns:a16="http://schemas.microsoft.com/office/drawing/2014/main" id="{CF34E5BC-0225-0349-8ED8-D822F406E1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47735" y="3804880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+48</a:t>
            </a:r>
          </a:p>
        </p:txBody>
      </p:sp>
      <p:sp>
        <p:nvSpPr>
          <p:cNvPr id="79" name="TextBox 29">
            <a:extLst>
              <a:ext uri="{FF2B5EF4-FFF2-40B4-BE49-F238E27FC236}">
                <a16:creationId xmlns:a16="http://schemas.microsoft.com/office/drawing/2014/main" id="{49A98EBE-3D37-F249-B48D-F2205E3DD1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5787" y="2995904"/>
            <a:ext cx="11729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 err="1">
                <a:solidFill>
                  <a:srgbClr val="FFFFFF"/>
                </a:solidFill>
              </a:rPr>
              <a:t>dACC</a:t>
            </a:r>
            <a:endParaRPr lang="en-US" sz="1200" dirty="0">
              <a:solidFill>
                <a:srgbClr val="FFFFFF"/>
              </a:solidFill>
            </a:endParaRPr>
          </a:p>
        </p:txBody>
      </p:sp>
      <p:sp>
        <p:nvSpPr>
          <p:cNvPr id="87" name="TextBox 29">
            <a:extLst>
              <a:ext uri="{FF2B5EF4-FFF2-40B4-BE49-F238E27FC236}">
                <a16:creationId xmlns:a16="http://schemas.microsoft.com/office/drawing/2014/main" id="{54E06C44-D173-5443-A462-550082FDB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5084" y="3373642"/>
            <a:ext cx="117297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Sens-</a:t>
            </a:r>
          </a:p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mot</a:t>
            </a: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62D4D8FA-3DF3-E849-8DF6-70CB6850D47B}"/>
              </a:ext>
            </a:extLst>
          </p:cNvPr>
          <p:cNvCxnSpPr>
            <a:cxnSpLocks/>
          </p:cNvCxnSpPr>
          <p:nvPr/>
        </p:nvCxnSpPr>
        <p:spPr>
          <a:xfrm flipH="1">
            <a:off x="4720021" y="3151771"/>
            <a:ext cx="387950" cy="19663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590E5606-D447-9D42-BE3A-C2B1E3BE8EF5}"/>
              </a:ext>
            </a:extLst>
          </p:cNvPr>
          <p:cNvCxnSpPr>
            <a:cxnSpLocks/>
          </p:cNvCxnSpPr>
          <p:nvPr/>
        </p:nvCxnSpPr>
        <p:spPr>
          <a:xfrm flipH="1" flipV="1">
            <a:off x="4997991" y="3511748"/>
            <a:ext cx="180507" cy="7255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7" name="Picture 26">
            <a:extLst>
              <a:ext uri="{FF2B5EF4-FFF2-40B4-BE49-F238E27FC236}">
                <a16:creationId xmlns:a16="http://schemas.microsoft.com/office/drawing/2014/main" id="{8D7BF95C-735D-364F-A54B-D0F281C9BE3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53644" y="4150832"/>
            <a:ext cx="971113" cy="1087126"/>
          </a:xfrm>
          <a:prstGeom prst="rect">
            <a:avLst/>
          </a:prstGeom>
        </p:spPr>
      </p:pic>
      <p:sp>
        <p:nvSpPr>
          <p:cNvPr id="95" name="TextBox 40">
            <a:extLst>
              <a:ext uri="{FF2B5EF4-FFF2-40B4-BE49-F238E27FC236}">
                <a16:creationId xmlns:a16="http://schemas.microsoft.com/office/drawing/2014/main" id="{1B948B46-CFBE-254F-847A-A2E366A132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3826" y="4917782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000" dirty="0">
                <a:solidFill>
                  <a:srgbClr val="FFFFFF"/>
                </a:solidFill>
              </a:rPr>
              <a:t>z=+66</a:t>
            </a:r>
          </a:p>
        </p:txBody>
      </p:sp>
      <p:sp>
        <p:nvSpPr>
          <p:cNvPr id="96" name="TextBox 29">
            <a:extLst>
              <a:ext uri="{FF2B5EF4-FFF2-40B4-BE49-F238E27FC236}">
                <a16:creationId xmlns:a16="http://schemas.microsoft.com/office/drawing/2014/main" id="{7ED6F920-B3BA-4146-BA81-86A74879C2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1729" y="4250431"/>
            <a:ext cx="64755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/>
            <a:r>
              <a:rPr lang="en-US" sz="1200" dirty="0">
                <a:solidFill>
                  <a:srgbClr val="FFFFFF"/>
                </a:solidFill>
              </a:rPr>
              <a:t>SMA</a:t>
            </a:r>
          </a:p>
        </p:txBody>
      </p: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12C2F03D-FDCA-A346-9EB3-A1012DCB0081}"/>
              </a:ext>
            </a:extLst>
          </p:cNvPr>
          <p:cNvCxnSpPr>
            <a:cxnSpLocks/>
            <a:stCxn id="96" idx="1"/>
          </p:cNvCxnSpPr>
          <p:nvPr/>
        </p:nvCxnSpPr>
        <p:spPr>
          <a:xfrm flipH="1">
            <a:off x="4723891" y="4388931"/>
            <a:ext cx="317838" cy="185095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BEED1285-1EE2-1249-8272-944F42AB8880}"/>
              </a:ext>
            </a:extLst>
          </p:cNvPr>
          <p:cNvCxnSpPr>
            <a:stCxn id="33" idx="1"/>
          </p:cNvCxnSpPr>
          <p:nvPr/>
        </p:nvCxnSpPr>
        <p:spPr>
          <a:xfrm>
            <a:off x="6870274" y="4634519"/>
            <a:ext cx="0" cy="2278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9" name="Text Box 3">
            <a:extLst>
              <a:ext uri="{FF2B5EF4-FFF2-40B4-BE49-F238E27FC236}">
                <a16:creationId xmlns:a16="http://schemas.microsoft.com/office/drawing/2014/main" id="{DA4B22B3-5FF6-B844-B173-047FF3D42C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6677" y="1339489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BE &gt; Non-BE</a:t>
            </a:r>
          </a:p>
        </p:txBody>
      </p:sp>
      <p:sp>
        <p:nvSpPr>
          <p:cNvPr id="120" name="Text Box 14">
            <a:extLst>
              <a:ext uri="{FF2B5EF4-FFF2-40B4-BE49-F238E27FC236}">
                <a16:creationId xmlns:a16="http://schemas.microsoft.com/office/drawing/2014/main" id="{4AF33433-AA50-6C49-9562-368FBC0077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6685" y="1088081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Non Stress Condition </a:t>
            </a:r>
          </a:p>
        </p:txBody>
      </p:sp>
      <p:sp>
        <p:nvSpPr>
          <p:cNvPr id="121" name="Text Box 14">
            <a:extLst>
              <a:ext uri="{FF2B5EF4-FFF2-40B4-BE49-F238E27FC236}">
                <a16:creationId xmlns:a16="http://schemas.microsoft.com/office/drawing/2014/main" id="{F51F4B29-0D31-CB48-8C60-42F360D6A4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56334" y="1066801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Stress Condition </a:t>
            </a:r>
          </a:p>
        </p:txBody>
      </p:sp>
      <p:sp>
        <p:nvSpPr>
          <p:cNvPr id="122" name="Text Box 3">
            <a:extLst>
              <a:ext uri="{FF2B5EF4-FFF2-40B4-BE49-F238E27FC236}">
                <a16:creationId xmlns:a16="http://schemas.microsoft.com/office/drawing/2014/main" id="{247A1CDF-7DB8-0945-945B-07ED1EAA55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93500" y="1337500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BE &gt; Non-BE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8382001" y="5013525"/>
            <a:ext cx="1853287" cy="246221"/>
          </a:xfrm>
          <a:prstGeom prst="rect">
            <a:avLst/>
          </a:prstGeom>
          <a:noFill/>
          <a:ln>
            <a:noFill/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US" altLang="zh-CN" sz="1000" dirty="0">
                <a:solidFill>
                  <a:srgbClr val="FFFFFF"/>
                </a:solidFill>
              </a:rPr>
              <a:t>Posterior probability &gt;98.75% </a:t>
            </a:r>
            <a:endParaRPr lang="en-US" altLang="zh-CN" sz="1000" dirty="0">
              <a:solidFill>
                <a:srgbClr val="000000"/>
              </a:solidFill>
            </a:endParaRP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F7BA430C-AC9B-4A93-AD53-E6FCF8CD32C0}"/>
              </a:ext>
            </a:extLst>
          </p:cNvPr>
          <p:cNvGrpSpPr/>
          <p:nvPr/>
        </p:nvGrpSpPr>
        <p:grpSpPr>
          <a:xfrm>
            <a:off x="8067862" y="4485714"/>
            <a:ext cx="2488104" cy="320204"/>
            <a:chOff x="4267202" y="5438365"/>
            <a:chExt cx="2488104" cy="320204"/>
          </a:xfrm>
        </p:grpSpPr>
        <p:grpSp>
          <p:nvGrpSpPr>
            <p:cNvPr id="72" name="Group 138">
              <a:extLst>
                <a:ext uri="{FF2B5EF4-FFF2-40B4-BE49-F238E27FC236}">
                  <a16:creationId xmlns:a16="http://schemas.microsoft.com/office/drawing/2014/main" id="{943B5AAC-A2E1-48CA-8A00-3B2145811A7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67202" y="5440365"/>
              <a:ext cx="2249620" cy="318204"/>
              <a:chOff x="3599542" y="6265456"/>
              <a:chExt cx="2249636" cy="317891"/>
            </a:xfrm>
          </p:grpSpPr>
          <p:pic>
            <p:nvPicPr>
              <p:cNvPr id="104" name="Picture 30" descr="blueColorbar">
                <a:extLst>
                  <a:ext uri="{FF2B5EF4-FFF2-40B4-BE49-F238E27FC236}">
                    <a16:creationId xmlns:a16="http://schemas.microsoft.com/office/drawing/2014/main" id="{BF0C2020-C502-4C41-9CF9-E6B667D776C9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4845364" y="6483261"/>
                <a:ext cx="1003814" cy="93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5" name="Picture 31" descr="redColorbar">
                <a:extLst>
                  <a:ext uri="{FF2B5EF4-FFF2-40B4-BE49-F238E27FC236}">
                    <a16:creationId xmlns:a16="http://schemas.microsoft.com/office/drawing/2014/main" id="{AB39D843-D926-4B20-86D3-466E7F644C3C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3711459" y="6489632"/>
                <a:ext cx="1139610" cy="937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6" name="Text Box 32">
                <a:extLst>
                  <a:ext uri="{FF2B5EF4-FFF2-40B4-BE49-F238E27FC236}">
                    <a16:creationId xmlns:a16="http://schemas.microsoft.com/office/drawing/2014/main" id="{F3023465-A3D7-43EA-B704-1BB98C0B737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99542" y="6265456"/>
                <a:ext cx="752041" cy="2459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1000" dirty="0">
                    <a:solidFill>
                      <a:schemeClr val="bg1"/>
                    </a:solidFill>
                    <a:cs typeface="Arial" charset="0"/>
                  </a:rPr>
                  <a:t> </a:t>
                </a:r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9.99%</a:t>
                </a:r>
                <a:endParaRPr lang="en-US" altLang="zh-CN" sz="1000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  <p:sp>
            <p:nvSpPr>
              <p:cNvPr id="107" name="Text Box 32">
                <a:extLst>
                  <a:ext uri="{FF2B5EF4-FFF2-40B4-BE49-F238E27FC236}">
                    <a16:creationId xmlns:a16="http://schemas.microsoft.com/office/drawing/2014/main" id="{EC9CE9CD-BB24-42F6-BF02-33EA6776570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05323" y="6265456"/>
                <a:ext cx="630105" cy="2306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8.75% </a:t>
                </a:r>
              </a:p>
            </p:txBody>
          </p:sp>
        </p:grpSp>
        <p:sp>
          <p:nvSpPr>
            <p:cNvPr id="74" name="Text Box 32">
              <a:extLst>
                <a:ext uri="{FF2B5EF4-FFF2-40B4-BE49-F238E27FC236}">
                  <a16:creationId xmlns:a16="http://schemas.microsoft.com/office/drawing/2014/main" id="{3F22F142-A1BA-4554-AB5B-337F97AF7D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88299" y="5440364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 -98.75%</a:t>
              </a:r>
            </a:p>
          </p:txBody>
        </p:sp>
        <p:sp>
          <p:nvSpPr>
            <p:cNvPr id="75" name="Text Box 32">
              <a:extLst>
                <a:ext uri="{FF2B5EF4-FFF2-40B4-BE49-F238E27FC236}">
                  <a16:creationId xmlns:a16="http://schemas.microsoft.com/office/drawing/2014/main" id="{BB685C43-582E-4C53-9935-2DA3FF2A74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190" y="5438365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-99.99%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37577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96</Words>
  <Application>Microsoft Macintosh PowerPoint</Application>
  <PresentationFormat>Widescreen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10</cp:revision>
  <dcterms:created xsi:type="dcterms:W3CDTF">2021-05-24T12:55:43Z</dcterms:created>
  <dcterms:modified xsi:type="dcterms:W3CDTF">2022-08-31T20:49:05Z</dcterms:modified>
</cp:coreProperties>
</file>